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68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68"/>
    <p:restoredTop sz="94609"/>
  </p:normalViewPr>
  <p:slideViewPr>
    <p:cSldViewPr snapToGrid="0">
      <p:cViewPr varScale="1">
        <p:scale>
          <a:sx n="113" d="100"/>
          <a:sy n="113" d="100"/>
        </p:scale>
        <p:origin x="33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333865-40B2-6249-89FB-0719449F8DE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6502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6B9A83B-4B97-2A3D-3BE7-2384461339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8658765"/>
              </p:ext>
            </p:extLst>
          </p:nvPr>
        </p:nvGraphicFramePr>
        <p:xfrm>
          <a:off x="545689" y="851153"/>
          <a:ext cx="5349792" cy="30276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17003">
                  <a:extLst>
                    <a:ext uri="{9D8B030D-6E8A-4147-A177-3AD203B41FA5}">
                      <a16:colId xmlns:a16="http://schemas.microsoft.com/office/drawing/2014/main" val="1351602184"/>
                    </a:ext>
                  </a:extLst>
                </a:gridCol>
                <a:gridCol w="666261">
                  <a:extLst>
                    <a:ext uri="{9D8B030D-6E8A-4147-A177-3AD203B41FA5}">
                      <a16:colId xmlns:a16="http://schemas.microsoft.com/office/drawing/2014/main" val="61465434"/>
                    </a:ext>
                  </a:extLst>
                </a:gridCol>
                <a:gridCol w="891632">
                  <a:extLst>
                    <a:ext uri="{9D8B030D-6E8A-4147-A177-3AD203B41FA5}">
                      <a16:colId xmlns:a16="http://schemas.microsoft.com/office/drawing/2014/main" val="2035381390"/>
                    </a:ext>
                  </a:extLst>
                </a:gridCol>
                <a:gridCol w="891632">
                  <a:extLst>
                    <a:ext uri="{9D8B030D-6E8A-4147-A177-3AD203B41FA5}">
                      <a16:colId xmlns:a16="http://schemas.microsoft.com/office/drawing/2014/main" val="1253428550"/>
                    </a:ext>
                  </a:extLst>
                </a:gridCol>
                <a:gridCol w="891632">
                  <a:extLst>
                    <a:ext uri="{9D8B030D-6E8A-4147-A177-3AD203B41FA5}">
                      <a16:colId xmlns:a16="http://schemas.microsoft.com/office/drawing/2014/main" val="454480595"/>
                    </a:ext>
                  </a:extLst>
                </a:gridCol>
                <a:gridCol w="891632">
                  <a:extLst>
                    <a:ext uri="{9D8B030D-6E8A-4147-A177-3AD203B41FA5}">
                      <a16:colId xmlns:a16="http://schemas.microsoft.com/office/drawing/2014/main" val="356579946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reatment Type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(N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-index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djusted HR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5% CI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djusted 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p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R median rwPFS (months)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5% CI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MR Median rwPFS (months)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5% CI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83009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IO (anti-PDL1 and/or CTLA4)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(361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7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29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21-0.42]</a:t>
                      </a:r>
                    </a:p>
                    <a:p>
                      <a:pPr algn="ctr"/>
                      <a:endParaRPr lang="en-US" sz="900"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NR-NR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.53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3.98-6.03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100394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IO + chemo/other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(158)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67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38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24-0.60]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9.13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7.23-NR]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.43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3.2—5.10]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6688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reatment Typ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-index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djusted HR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5% CI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djusted p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R median rwOS (months)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5% CI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MR Median rwOS (months)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5% CI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65463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IO (anti-PDL1 and/or CTLA4)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(361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7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32</a:t>
                      </a:r>
                    </a:p>
                    <a:p>
                      <a:pPr algn="ctr"/>
                      <a:r>
                        <a:rPr lang="en-US" sz="900" dirty="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21-0.50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NR-NR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0.97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.10-NR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2477306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IO + chemo/other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(158)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69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40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24-0.68]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</a:t>
                      </a:r>
                    </a:p>
                    <a:p>
                      <a:pPr algn="ctr"/>
                      <a:r>
                        <a:rPr lang="en-US" sz="9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.53-NR]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.6</a:t>
                      </a:r>
                    </a:p>
                    <a:p>
                      <a:pPr algn="ctr"/>
                      <a:r>
                        <a:rPr lang="en-US" sz="900" dirty="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5.70-11.27]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534078"/>
                  </a:ext>
                </a:extLst>
              </a:tr>
            </a:tbl>
          </a:graphicData>
        </a:graphic>
      </p:graphicFrame>
      <p:sp>
        <p:nvSpPr>
          <p:cNvPr id="7" name="Rectangle 1">
            <a:extLst>
              <a:ext uri="{FF2B5EF4-FFF2-40B4-BE49-F238E27FC236}">
                <a16:creationId xmlns:a16="http://schemas.microsoft.com/office/drawing/2014/main" id="{591830CF-9812-EF41-E9A4-095987E4B3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5691" y="3956447"/>
            <a:ext cx="5349790" cy="615553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 Neue" panose="02000503000000020004" pitchFamily="2" charset="0"/>
              </a:rPr>
              <a:t>Supplementary Table S5. Longitudinal assessment of TF predicts ICI benefit for patients treated with ICI and ICI + chemo/other therapies (n=519). Adjusted HR, p-value, c-index and median rwPFS and rwOS for MR and nMR for patients treated with immunotherapy only versus those treated with a combination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77B87FC-AAD2-0726-5824-26BAE020E45F}"/>
              </a:ext>
            </a:extLst>
          </p:cNvPr>
          <p:cNvSpPr txBox="1"/>
          <p:nvPr/>
        </p:nvSpPr>
        <p:spPr>
          <a:xfrm>
            <a:off x="462844" y="404207"/>
            <a:ext cx="34318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 Neue" panose="02000503000000020004" pitchFamily="2" charset="0"/>
              </a:rPr>
              <a:t>Supplementary Table S5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877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1</TotalTime>
  <Words>229</Words>
  <Application>Microsoft Macintosh PowerPoint</Application>
  <PresentationFormat>Letter Paper (8.5x11 in)</PresentationFormat>
  <Paragraphs>6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3</cp:revision>
  <dcterms:created xsi:type="dcterms:W3CDTF">2024-12-13T18:22:33Z</dcterms:created>
  <dcterms:modified xsi:type="dcterms:W3CDTF">2025-07-09T17:10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